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1" r:id="rId2"/>
  </p:sldIdLst>
  <p:sldSz cx="6858000" cy="9906000" type="A4"/>
  <p:notesSz cx="6797675" cy="9926638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8FEEC"/>
    <a:srgbClr val="663300"/>
    <a:srgbClr val="996633"/>
    <a:srgbClr val="F8C1B6"/>
    <a:srgbClr val="2FFFCD"/>
    <a:srgbClr val="FF47FF"/>
    <a:srgbClr val="F03218"/>
    <a:srgbClr val="FFCC00"/>
    <a:srgbClr val="096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3820" autoAdjust="0"/>
    <p:restoredTop sz="86407" autoAdjust="0"/>
  </p:normalViewPr>
  <p:slideViewPr>
    <p:cSldViewPr snapToGrid="0">
      <p:cViewPr varScale="1">
        <p:scale>
          <a:sx n="99" d="100"/>
          <a:sy n="99" d="100"/>
        </p:scale>
        <p:origin x="1956" y="10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13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1275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1275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665EB616-CABF-4B7C-8565-3F13A2DBAE3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098549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3B58F2DE-17C5-4142-9F39-686B0848F31E}" type="datetimeFigureOut">
              <a:rPr lang="en-US"/>
              <a:pPr>
                <a:defRPr/>
              </a:pPr>
              <a:t>5/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04DFB875-2F53-4D6C-ADAB-812F19EB2EE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41754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9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3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C7B3581-3040-4C47-ADF3-F7D4BDF131E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997098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717908-283F-4A2E-8FCF-7BC83614E92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835667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31" y="881063"/>
            <a:ext cx="1457325" cy="7924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5" y="881063"/>
            <a:ext cx="4219575" cy="7924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B84506-8937-496E-A9A5-506A604EF8F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592984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F88204-B65D-423C-82DF-4A8B8B464684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52936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8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8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8640E2-38E6-4B95-8168-088FE1B739E8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615939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DE9D79-45D0-4CF4-9705-888B56937B2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673268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6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9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9" y="3141666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1736B4A-D98C-4FDE-82E5-666406FC6D72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334067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D88AC4-24D4-4E5E-9378-7ED6E2E80DB9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330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83B130-67A1-42C9-9B68-17CCECACC0B3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66157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3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4"/>
            <a:ext cx="2255838" cy="67754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2EAF75-1BEF-4565-B096-D8E8C0F6EE3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18544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49"/>
            <a:ext cx="4114800" cy="11620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3C5CCA-D13F-480E-AAE9-F766CFFA9F86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204788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ext styles</a:t>
            </a:r>
          </a:p>
          <a:p>
            <a:pPr lvl="1"/>
            <a:r>
              <a:rPr lang="en-GB" altLang="zh-CN" smtClean="0"/>
              <a:t>Second level</a:t>
            </a:r>
          </a:p>
          <a:p>
            <a:pPr lvl="2"/>
            <a:r>
              <a:rPr lang="en-GB" altLang="zh-CN" smtClean="0"/>
              <a:t>Third level</a:t>
            </a:r>
          </a:p>
          <a:p>
            <a:pPr lvl="3"/>
            <a:r>
              <a:rPr lang="en-GB" altLang="zh-CN" smtClean="0"/>
              <a:t>Fourth level</a:t>
            </a:r>
          </a:p>
          <a:p>
            <a:pPr lvl="4"/>
            <a:r>
              <a:rPr lang="en-GB" altLang="zh-CN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fld id="{CFB04EDC-854A-47E1-A7BC-53B84277158A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62995" y="8854572"/>
            <a:ext cx="615950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</a:t>
            </a:r>
            <a:r>
              <a:rPr lang="en-GB" sz="11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2. 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Examples of mutations identified by </a:t>
            </a:r>
            <a:r>
              <a:rPr lang="en-GB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HaloPlex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 target enrichment and Illumina </a:t>
            </a:r>
            <a:r>
              <a:rPr lang="en-GB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Hiseq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 sequencing in thyroid MALT lymphoma.  Aligned reads were transformed to a bam file and visualised using IGV software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C85E84D-C789-4E5B-B14B-CDF90C7CA287}"/>
              </a:ext>
            </a:extLst>
          </p:cNvPr>
          <p:cNvGrpSpPr/>
          <p:nvPr/>
        </p:nvGrpSpPr>
        <p:grpSpPr>
          <a:xfrm>
            <a:off x="154462" y="690400"/>
            <a:ext cx="6417130" cy="8022280"/>
            <a:chOff x="40891" y="379889"/>
            <a:chExt cx="6417130" cy="8022280"/>
          </a:xfrm>
        </p:grpSpPr>
        <p:sp>
          <p:nvSpPr>
            <p:cNvPr id="4" name="TextBox 9">
              <a:extLst>
                <a:ext uri="{FF2B5EF4-FFF2-40B4-BE49-F238E27FC236}">
                  <a16:creationId xmlns:a16="http://schemas.microsoft.com/office/drawing/2014/main" id="{B14593AE-C133-430D-B32F-4DFD0EDA6F8C}"/>
                </a:ext>
              </a:extLst>
            </p:cNvPr>
            <p:cNvSpPr txBox="1"/>
            <p:nvPr/>
          </p:nvSpPr>
          <p:spPr>
            <a:xfrm>
              <a:off x="139538" y="873413"/>
              <a:ext cx="1447577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altLang="zh-CN" sz="1200" b="1" i="1" dirty="0">
                  <a:latin typeface="Calibri" panose="020F0502020204030204" pitchFamily="34" charset="0"/>
                  <a:cs typeface="Calibri" panose="020F0502020204030204" pitchFamily="34" charset="0"/>
                </a:rPr>
                <a:t>CD274</a:t>
              </a:r>
            </a:p>
            <a:p>
              <a:pPr algn="ctr"/>
              <a:r>
                <a:rPr lang="en-GB" altLang="zh-CN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TM_68</a:t>
              </a:r>
            </a:p>
            <a:p>
              <a:pPr algn="ctr"/>
              <a:r>
                <a:rPr lang="en-GB" altLang="zh-CN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Nonsense mutation</a:t>
              </a:r>
            </a:p>
            <a:p>
              <a:pPr algn="ctr"/>
              <a:r>
                <a:rPr lang="en-GB" altLang="zh-CN" sz="12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c.613G&gt;T; p.E205X</a:t>
              </a:r>
              <a:endParaRPr lang="zh-CN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" name="TextBox 10">
              <a:extLst>
                <a:ext uri="{FF2B5EF4-FFF2-40B4-BE49-F238E27FC236}">
                  <a16:creationId xmlns:a16="http://schemas.microsoft.com/office/drawing/2014/main" id="{626E33AC-391E-4031-BCFF-352B973EFB28}"/>
                </a:ext>
              </a:extLst>
            </p:cNvPr>
            <p:cNvSpPr txBox="1"/>
            <p:nvPr/>
          </p:nvSpPr>
          <p:spPr>
            <a:xfrm>
              <a:off x="160636" y="2975541"/>
              <a:ext cx="1405385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altLang="zh-CN" sz="1200" b="1" i="1" dirty="0">
                  <a:latin typeface="Calibri" panose="020F0502020204030204" pitchFamily="34" charset="0"/>
                  <a:cs typeface="Calibri" panose="020F0502020204030204" pitchFamily="34" charset="0"/>
                </a:rPr>
                <a:t>CD274</a:t>
              </a:r>
            </a:p>
            <a:p>
              <a:pPr algn="ctr"/>
              <a:r>
                <a:rPr lang="en-GB" altLang="zh-CN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TM_31</a:t>
              </a:r>
            </a:p>
            <a:p>
              <a:pPr algn="ctr"/>
              <a:r>
                <a:rPr lang="en-US" altLang="zh-CN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Frameshift deletion</a:t>
              </a:r>
              <a:endParaRPr lang="en-GB" altLang="zh-CN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  <a:p>
              <a:pPr algn="ctr"/>
              <a:r>
                <a:rPr lang="en-GB" altLang="zh-CN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c.</a:t>
              </a:r>
              <a:r>
                <a:rPr lang="en-US" altLang="zh-CN" sz="12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85del; </a:t>
              </a:r>
              <a:r>
                <a:rPr lang="en-GB" altLang="zh-CN" sz="12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p.</a:t>
              </a:r>
              <a:r>
                <a:rPr lang="en-US" altLang="zh-CN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V29fs</a:t>
              </a:r>
              <a:endParaRPr lang="zh-CN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" name="TextBox 11">
              <a:extLst>
                <a:ext uri="{FF2B5EF4-FFF2-40B4-BE49-F238E27FC236}">
                  <a16:creationId xmlns:a16="http://schemas.microsoft.com/office/drawing/2014/main" id="{05FEC561-EF37-41F1-B310-8F6DA0759733}"/>
                </a:ext>
              </a:extLst>
            </p:cNvPr>
            <p:cNvSpPr txBox="1"/>
            <p:nvPr/>
          </p:nvSpPr>
          <p:spPr>
            <a:xfrm>
              <a:off x="141974" y="5077669"/>
              <a:ext cx="1442704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altLang="zh-CN" sz="1200" b="1" i="1" dirty="0">
                  <a:latin typeface="Calibri" panose="020F0502020204030204" pitchFamily="34" charset="0"/>
                  <a:cs typeface="Calibri" panose="020F0502020204030204" pitchFamily="34" charset="0"/>
                </a:rPr>
                <a:t>TNFRSF14</a:t>
              </a:r>
            </a:p>
            <a:p>
              <a:pPr algn="ctr"/>
              <a:r>
                <a:rPr lang="en-GB" altLang="zh-CN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TM_51</a:t>
              </a:r>
            </a:p>
            <a:p>
              <a:pPr algn="ctr"/>
              <a:r>
                <a:rPr lang="en-GB" altLang="zh-CN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Nonsense mutation</a:t>
              </a:r>
            </a:p>
            <a:p>
              <a:pPr algn="ctr"/>
              <a:r>
                <a:rPr lang="en-US" altLang="zh-CN" sz="12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c.388C&gt;T; p.Q130X</a:t>
              </a:r>
              <a:endParaRPr lang="zh-CN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" name="TextBox 12">
              <a:extLst>
                <a:ext uri="{FF2B5EF4-FFF2-40B4-BE49-F238E27FC236}">
                  <a16:creationId xmlns:a16="http://schemas.microsoft.com/office/drawing/2014/main" id="{DD53EF1B-E0C5-4B65-B7D9-7C521E0235B6}"/>
                </a:ext>
              </a:extLst>
            </p:cNvPr>
            <p:cNvSpPr txBox="1"/>
            <p:nvPr/>
          </p:nvSpPr>
          <p:spPr>
            <a:xfrm>
              <a:off x="40891" y="7179797"/>
              <a:ext cx="1644874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altLang="zh-CN" sz="1200" b="1" i="1" dirty="0">
                  <a:latin typeface="Calibri" panose="020F0502020204030204" pitchFamily="34" charset="0"/>
                  <a:cs typeface="Calibri" panose="020F0502020204030204" pitchFamily="34" charset="0"/>
                </a:rPr>
                <a:t>TNFRSF14</a:t>
              </a:r>
            </a:p>
            <a:p>
              <a:pPr algn="ctr"/>
              <a:r>
                <a:rPr lang="en-GB" altLang="zh-CN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TM_19</a:t>
              </a:r>
            </a:p>
            <a:p>
              <a:pPr algn="ctr"/>
              <a:r>
                <a:rPr lang="en-GB" altLang="zh-CN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Frameshift deletion</a:t>
              </a:r>
            </a:p>
            <a:p>
              <a:pPr algn="ctr"/>
              <a:r>
                <a:rPr lang="en-US" altLang="zh-CN" sz="12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c.404_410del; p.C135fs</a:t>
              </a:r>
              <a:endParaRPr lang="zh-CN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94C1AAE-7E40-4DA1-8BB8-0CB440D8C90D}"/>
                </a:ext>
              </a:extLst>
            </p:cNvPr>
            <p:cNvGrpSpPr/>
            <p:nvPr/>
          </p:nvGrpSpPr>
          <p:grpSpPr>
            <a:xfrm>
              <a:off x="1682883" y="379889"/>
              <a:ext cx="4775138" cy="1821546"/>
              <a:chOff x="1682883" y="379889"/>
              <a:chExt cx="4775138" cy="1821546"/>
            </a:xfrm>
          </p:grpSpPr>
          <p:pic>
            <p:nvPicPr>
              <p:cNvPr id="30" name="Content Placeholder 3">
                <a:extLst>
                  <a:ext uri="{FF2B5EF4-FFF2-40B4-BE49-F238E27FC236}">
                    <a16:creationId xmlns:a16="http://schemas.microsoft.com/office/drawing/2014/main" id="{725D227E-7A52-4FC4-97ED-DFEC30CC8D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682883" y="379889"/>
                <a:ext cx="3492233" cy="1821546"/>
              </a:xfrm>
              <a:prstGeom prst="rect">
                <a:avLst/>
              </a:prstGeom>
            </p:spPr>
          </p:pic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C0320EC8-5F25-42BA-9BD6-BA38ACED36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952925" y="790519"/>
                <a:ext cx="446797" cy="94413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4027DE6A-F969-483C-B19C-5EE57C2A632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935" r="-1"/>
              <a:stretch/>
            </p:blipFill>
            <p:spPr>
              <a:xfrm>
                <a:off x="5516309" y="897390"/>
                <a:ext cx="941712" cy="77725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6AC0E1FD-4B72-40DC-92BA-8EE32DF410A0}"/>
                  </a:ext>
                </a:extLst>
              </p:cNvPr>
              <p:cNvSpPr/>
              <p:nvPr/>
            </p:nvSpPr>
            <p:spPr>
              <a:xfrm>
                <a:off x="3332707" y="1135065"/>
                <a:ext cx="267331" cy="9784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84E401BF-7723-4806-94E3-2E408EC94A2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600038" y="790520"/>
                <a:ext cx="352887" cy="344545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ECEDCA8D-F01A-4EEB-B680-4B2B54C356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00038" y="1232906"/>
                <a:ext cx="352887" cy="50905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9E9450D1-75F8-469E-8599-406BF6E43546}"/>
                </a:ext>
              </a:extLst>
            </p:cNvPr>
            <p:cNvGrpSpPr/>
            <p:nvPr/>
          </p:nvGrpSpPr>
          <p:grpSpPr>
            <a:xfrm>
              <a:off x="1682883" y="2468305"/>
              <a:ext cx="4775138" cy="1840805"/>
              <a:chOff x="1682883" y="2468305"/>
              <a:chExt cx="4775138" cy="1840805"/>
            </a:xfrm>
          </p:grpSpPr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45824549-EDAA-49DD-8267-C0B28CF27C5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682883" y="2468305"/>
                <a:ext cx="3492233" cy="1840805"/>
              </a:xfrm>
              <a:prstGeom prst="rect">
                <a:avLst/>
              </a:prstGeom>
            </p:spPr>
          </p:pic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53ED3C2E-C411-4BD2-BEA8-D77203AB7E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763259" y="3119123"/>
                <a:ext cx="450158" cy="94413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E98FE9EE-1973-4EE1-875D-201FF728DD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516309" y="2932574"/>
                <a:ext cx="941712" cy="102347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34900AB5-B5C4-437D-B52A-4D82E6987058}"/>
                  </a:ext>
                </a:extLst>
              </p:cNvPr>
              <p:cNvSpPr/>
              <p:nvPr/>
            </p:nvSpPr>
            <p:spPr>
              <a:xfrm>
                <a:off x="3301806" y="3346472"/>
                <a:ext cx="267331" cy="9784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C00234C3-B15E-49A6-9425-FEB3687150A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569139" y="3119123"/>
                <a:ext cx="194120" cy="22734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B2D9D0A4-C6EC-4ADF-9CFF-B47E3DDF40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69137" y="3444313"/>
                <a:ext cx="194122" cy="61894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02CCE1FC-A96A-4E8E-A016-9CB600D0D961}"/>
                </a:ext>
              </a:extLst>
            </p:cNvPr>
            <p:cNvGrpSpPr/>
            <p:nvPr/>
          </p:nvGrpSpPr>
          <p:grpSpPr>
            <a:xfrm>
              <a:off x="1682883" y="4593317"/>
              <a:ext cx="4775138" cy="1797940"/>
              <a:chOff x="1682883" y="4593317"/>
              <a:chExt cx="4775138" cy="1797940"/>
            </a:xfrm>
          </p:grpSpPr>
          <p:pic>
            <p:nvPicPr>
              <p:cNvPr id="18" name="Content Placeholder 4">
                <a:extLst>
                  <a:ext uri="{FF2B5EF4-FFF2-40B4-BE49-F238E27FC236}">
                    <a16:creationId xmlns:a16="http://schemas.microsoft.com/office/drawing/2014/main" id="{8BAEC9E1-CFD4-49B1-915F-EBDFCDFFDB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595" t="13412" r="1553" b="8926"/>
              <a:stretch/>
            </p:blipFill>
            <p:spPr>
              <a:xfrm>
                <a:off x="1682883" y="4593317"/>
                <a:ext cx="3492233" cy="1797940"/>
              </a:xfrm>
              <a:prstGeom prst="rect">
                <a:avLst/>
              </a:prstGeom>
            </p:spPr>
          </p:pic>
          <p:pic>
            <p:nvPicPr>
              <p:cNvPr id="19" name="Content Placeholder 4">
                <a:extLst>
                  <a:ext uri="{FF2B5EF4-FFF2-40B4-BE49-F238E27FC236}">
                    <a16:creationId xmlns:a16="http://schemas.microsoft.com/office/drawing/2014/main" id="{860F46A1-CDF2-4323-84E3-D18D0D9A14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231" t="37628" r="38179" b="14182"/>
              <a:stretch/>
            </p:blipFill>
            <p:spPr>
              <a:xfrm>
                <a:off x="3952925" y="4876425"/>
                <a:ext cx="460032" cy="130038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0" name="Content Placeholder 4">
                <a:extLst>
                  <a:ext uri="{FF2B5EF4-FFF2-40B4-BE49-F238E27FC236}">
                    <a16:creationId xmlns:a16="http://schemas.microsoft.com/office/drawing/2014/main" id="{2103A2FC-9DF8-4487-AEF0-3C6A65EF5C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690" t="39654" r="29967" b="40260"/>
              <a:stretch/>
            </p:blipFill>
            <p:spPr>
              <a:xfrm>
                <a:off x="5516309" y="5095604"/>
                <a:ext cx="941712" cy="86202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A011400D-6641-4B4E-BF19-0F299F940C03}"/>
                  </a:ext>
                </a:extLst>
              </p:cNvPr>
              <p:cNvSpPr/>
              <p:nvPr/>
            </p:nvSpPr>
            <p:spPr>
              <a:xfrm>
                <a:off x="3334711" y="5490303"/>
                <a:ext cx="267331" cy="9784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6439398F-076C-4FB4-9C29-AD12C10C69AD}"/>
                  </a:ext>
                </a:extLst>
              </p:cNvPr>
              <p:cNvCxnSpPr/>
              <p:nvPr/>
            </p:nvCxnSpPr>
            <p:spPr>
              <a:xfrm flipH="1">
                <a:off x="3600038" y="4876425"/>
                <a:ext cx="352887" cy="61387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EDD74A57-8E10-447F-BE5B-6395469369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00038" y="5588144"/>
                <a:ext cx="352887" cy="58866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CC7FA450-9AA0-48E7-89EC-ED9766A3C6B5}"/>
                </a:ext>
              </a:extLst>
            </p:cNvPr>
            <p:cNvGrpSpPr/>
            <p:nvPr/>
          </p:nvGrpSpPr>
          <p:grpSpPr>
            <a:xfrm>
              <a:off x="1682883" y="6810801"/>
              <a:ext cx="4775138" cy="1591368"/>
              <a:chOff x="1682883" y="6810801"/>
              <a:chExt cx="4775138" cy="1591368"/>
            </a:xfrm>
          </p:grpSpPr>
          <p:pic>
            <p:nvPicPr>
              <p:cNvPr id="12" name="Content Placeholder 5">
                <a:extLst>
                  <a:ext uri="{FF2B5EF4-FFF2-40B4-BE49-F238E27FC236}">
                    <a16:creationId xmlns:a16="http://schemas.microsoft.com/office/drawing/2014/main" id="{FDBEECC6-76B8-4857-A94A-0FACD445636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184" t="35434" r="25582" b="40260"/>
              <a:stretch/>
            </p:blipFill>
            <p:spPr>
              <a:xfrm>
                <a:off x="5516309" y="7154240"/>
                <a:ext cx="941712" cy="90448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" name="Content Placeholder 3">
                <a:extLst>
                  <a:ext uri="{FF2B5EF4-FFF2-40B4-BE49-F238E27FC236}">
                    <a16:creationId xmlns:a16="http://schemas.microsoft.com/office/drawing/2014/main" id="{742B346E-A11B-47F6-BD23-CD65DC23905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661" t="13717" r="1635" b="17663"/>
              <a:stretch/>
            </p:blipFill>
            <p:spPr>
              <a:xfrm>
                <a:off x="1682883" y="6810801"/>
                <a:ext cx="3492233" cy="1591368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B6A14397-E582-49E1-A2C3-340A3322BE2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973" t="34596" r="33470" b="22976"/>
              <a:stretch/>
            </p:blipFill>
            <p:spPr>
              <a:xfrm>
                <a:off x="4412957" y="7129190"/>
                <a:ext cx="542875" cy="10317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B1273524-2751-41C8-B375-65309C70A4D9}"/>
                  </a:ext>
                </a:extLst>
              </p:cNvPr>
              <p:cNvSpPr/>
              <p:nvPr/>
            </p:nvSpPr>
            <p:spPr>
              <a:xfrm>
                <a:off x="3362013" y="7543382"/>
                <a:ext cx="267331" cy="9784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124E716F-A0DA-4093-B881-4DDA0B48B26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629344" y="7129192"/>
                <a:ext cx="783613" cy="41419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82F15A0E-34C2-49F3-B201-B604B560C99F}"/>
                  </a:ext>
                </a:extLst>
              </p:cNvPr>
              <p:cNvCxnSpPr/>
              <p:nvPr/>
            </p:nvCxnSpPr>
            <p:spPr>
              <a:xfrm flipH="1" flipV="1">
                <a:off x="3629344" y="7641223"/>
                <a:ext cx="770378" cy="51974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387080154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Default Design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28</TotalTime>
  <Words>65</Words>
  <Application>Microsoft Office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宋体</vt:lpstr>
      <vt:lpstr>Calibri</vt:lpstr>
      <vt:lpstr>Times New Roman</vt:lpstr>
      <vt:lpstr>Default Design</vt:lpstr>
      <vt:lpstr>PowerPoint Presentation</vt:lpstr>
    </vt:vector>
  </TitlesOfParts>
  <Company>Cambrid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g Du</dc:creator>
  <cp:lastModifiedBy>Ming Du</cp:lastModifiedBy>
  <cp:revision>574</cp:revision>
  <dcterms:created xsi:type="dcterms:W3CDTF">2009-09-20T11:37:28Z</dcterms:created>
  <dcterms:modified xsi:type="dcterms:W3CDTF">2021-05-05T13:39:54Z</dcterms:modified>
</cp:coreProperties>
</file>